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6" r:id="rId2"/>
  </p:sldIdLst>
  <p:sldSz cx="7772400" cy="10058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25" autoAdjust="0"/>
    <p:restoredTop sz="76820" autoAdjust="0"/>
  </p:normalViewPr>
  <p:slideViewPr>
    <p:cSldViewPr snapToGrid="0">
      <p:cViewPr>
        <p:scale>
          <a:sx n="106" d="100"/>
          <a:sy n="106" d="100"/>
        </p:scale>
        <p:origin x="1152" y="-2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66EA922-8FD2-4522-ADA6-E36F4F189FDC}" type="datetimeFigureOut">
              <a:rPr lang="en-US" smtClean="0"/>
              <a:t>6/23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3C1B8F0-7B92-4C3D-B71D-D26FC784A2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08493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36788" y="1143000"/>
            <a:ext cx="23844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Figure S1: Comparison of survival curves before (the left panel) and after (the right panel) removal of the five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ice which died in the first week after giving EGCG. In such condition,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GCG had no significant effect (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=0.56) on the survival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rate when comparing EGCG-fed mice against the old control mice within 29 weeks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3C1B8F0-7B92-4C3D-B71D-D26FC784A2E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23895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E5C317-2A94-4F96-9433-88FE710AEADB}" type="datetimeFigureOut">
              <a:rPr lang="en-US" smtClean="0"/>
              <a:t>6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C7638-AF4B-4DAE-82FC-33FEF1A8EE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37804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E5C317-2A94-4F96-9433-88FE710AEADB}" type="datetimeFigureOut">
              <a:rPr lang="en-US" smtClean="0"/>
              <a:t>6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C7638-AF4B-4DAE-82FC-33FEF1A8EE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54362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E5C317-2A94-4F96-9433-88FE710AEADB}" type="datetimeFigureOut">
              <a:rPr lang="en-US" smtClean="0"/>
              <a:t>6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C7638-AF4B-4DAE-82FC-33FEF1A8EE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18722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E5C317-2A94-4F96-9433-88FE710AEADB}" type="datetimeFigureOut">
              <a:rPr lang="en-US" smtClean="0"/>
              <a:t>6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C7638-AF4B-4DAE-82FC-33FEF1A8EE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20995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E5C317-2A94-4F96-9433-88FE710AEADB}" type="datetimeFigureOut">
              <a:rPr lang="en-US" smtClean="0"/>
              <a:t>6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C7638-AF4B-4DAE-82FC-33FEF1A8EE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36819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E5C317-2A94-4F96-9433-88FE710AEADB}" type="datetimeFigureOut">
              <a:rPr lang="en-US" smtClean="0"/>
              <a:t>6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C7638-AF4B-4DAE-82FC-33FEF1A8EE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8635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E5C317-2A94-4F96-9433-88FE710AEADB}" type="datetimeFigureOut">
              <a:rPr lang="en-US" smtClean="0"/>
              <a:t>6/2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C7638-AF4B-4DAE-82FC-33FEF1A8EE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79543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E5C317-2A94-4F96-9433-88FE710AEADB}" type="datetimeFigureOut">
              <a:rPr lang="en-US" smtClean="0"/>
              <a:t>6/2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C7638-AF4B-4DAE-82FC-33FEF1A8EE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90526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E5C317-2A94-4F96-9433-88FE710AEADB}" type="datetimeFigureOut">
              <a:rPr lang="en-US" smtClean="0"/>
              <a:t>6/2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C7638-AF4B-4DAE-82FC-33FEF1A8EE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43057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E5C317-2A94-4F96-9433-88FE710AEADB}" type="datetimeFigureOut">
              <a:rPr lang="en-US" smtClean="0"/>
              <a:t>6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C7638-AF4B-4DAE-82FC-33FEF1A8EE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14952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E5C317-2A94-4F96-9433-88FE710AEADB}" type="datetimeFigureOut">
              <a:rPr lang="en-US" smtClean="0"/>
              <a:t>6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C7638-AF4B-4DAE-82FC-33FEF1A8EE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88299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E5C317-2A94-4F96-9433-88FE710AEADB}" type="datetimeFigureOut">
              <a:rPr lang="en-US" smtClean="0"/>
              <a:t>6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0C7638-AF4B-4DAE-82FC-33FEF1A8EE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10416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124607" y="841410"/>
            <a:ext cx="2575034" cy="20489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" name="Picture 4"/>
          <p:cNvPicPr/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163650" y="841409"/>
            <a:ext cx="2552461" cy="2048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TextBox 5"/>
          <p:cNvSpPr txBox="1"/>
          <p:nvPr/>
        </p:nvSpPr>
        <p:spPr>
          <a:xfrm>
            <a:off x="1124607" y="438920"/>
            <a:ext cx="7053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4283030" y="377115"/>
            <a:ext cx="7053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B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711001" y="4698351"/>
            <a:ext cx="630620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Figure S1: Comparison of survival curves before </a:t>
            </a:r>
            <a:r>
              <a:rPr lang="en-US" sz="1200" dirty="0" smtClean="0"/>
              <a:t>(A) </a:t>
            </a:r>
            <a:r>
              <a:rPr lang="en-US" sz="1200" dirty="0"/>
              <a:t>and after </a:t>
            </a:r>
            <a:r>
              <a:rPr lang="en-US" sz="1200" dirty="0" smtClean="0"/>
              <a:t>(B) </a:t>
            </a:r>
            <a:r>
              <a:rPr lang="en-US" sz="1200" dirty="0"/>
              <a:t>removal of the five mice which died in the first week after giving EGCG. In such condition </a:t>
            </a:r>
            <a:r>
              <a:rPr lang="en-US" sz="1200" dirty="0" smtClean="0"/>
              <a:t>(B), </a:t>
            </a:r>
            <a:r>
              <a:rPr lang="en-US" sz="1200" dirty="0"/>
              <a:t>EGCG had no significant effect (</a:t>
            </a:r>
            <a:r>
              <a:rPr lang="en-US" sz="1200" i="1" dirty="0"/>
              <a:t>p</a:t>
            </a:r>
            <a:r>
              <a:rPr lang="en-US" sz="1200" dirty="0"/>
              <a:t>=0.56) on the survival rate when comparing EGCG-fed mice against the old control mice within 29 weeks</a:t>
            </a:r>
            <a:r>
              <a:rPr lang="en-US" sz="1200" dirty="0" smtClean="0"/>
              <a:t>. </a:t>
            </a:r>
            <a:r>
              <a:rPr lang="en-US" sz="1200" dirty="0" smtClean="0"/>
              <a:t>This result may be affected by sharp decrease of water intake after EGCG administration at week 5 (C).</a:t>
            </a:r>
            <a:r>
              <a:rPr lang="en-US" sz="1200" dirty="0" smtClean="0"/>
              <a:t> </a:t>
            </a:r>
            <a:endParaRPr lang="en-US" sz="1200" dirty="0"/>
          </a:p>
          <a:p>
            <a:endParaRPr lang="en-US" sz="1200" dirty="0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1455" y="5772536"/>
            <a:ext cx="6905298" cy="2368822"/>
          </a:xfrm>
          <a:prstGeom prst="rect">
            <a:avLst/>
          </a:prstGeom>
        </p:spPr>
      </p:pic>
      <p:grpSp>
        <p:nvGrpSpPr>
          <p:cNvPr id="8" name="Group 7"/>
          <p:cNvGrpSpPr/>
          <p:nvPr/>
        </p:nvGrpSpPr>
        <p:grpSpPr>
          <a:xfrm>
            <a:off x="902444" y="2981945"/>
            <a:ext cx="2961660" cy="1814866"/>
            <a:chOff x="8443508" y="3209778"/>
            <a:chExt cx="2961660" cy="1814866"/>
          </a:xfrm>
        </p:grpSpPr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9021848" y="3398108"/>
              <a:ext cx="2161017" cy="1256735"/>
            </a:xfrm>
            <a:prstGeom prst="rect">
              <a:avLst/>
            </a:prstGeom>
          </p:spPr>
        </p:pic>
        <p:sp>
          <p:nvSpPr>
            <p:cNvPr id="10" name="TextBox 9"/>
            <p:cNvSpPr txBox="1"/>
            <p:nvPr/>
          </p:nvSpPr>
          <p:spPr>
            <a:xfrm rot="16200000">
              <a:off x="7882098" y="3797397"/>
              <a:ext cx="152293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Water</a:t>
              </a:r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Intake (mL/week/mouse)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8726942" y="3209778"/>
              <a:ext cx="368708" cy="1631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2400"/>
                </a:lnSpc>
              </a:pPr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40</a:t>
              </a:r>
            </a:p>
            <a:p>
              <a:pPr algn="ctr">
                <a:lnSpc>
                  <a:spcPts val="2400"/>
                </a:lnSpc>
              </a:pPr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30</a:t>
              </a:r>
            </a:p>
            <a:p>
              <a:pPr algn="ctr">
                <a:lnSpc>
                  <a:spcPts val="2400"/>
                </a:lnSpc>
              </a:pPr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20</a:t>
              </a:r>
            </a:p>
            <a:p>
              <a:pPr algn="ctr">
                <a:lnSpc>
                  <a:spcPts val="2400"/>
                </a:lnSpc>
              </a:pPr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10</a:t>
              </a:r>
            </a:p>
            <a:p>
              <a:pPr algn="ctr">
                <a:lnSpc>
                  <a:spcPts val="2400"/>
                </a:lnSpc>
              </a:pPr>
              <a:r>
                <a:rPr lang="en-US" sz="1000" b="1" dirty="0">
                  <a:latin typeface="Arial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8911296" y="4624534"/>
              <a:ext cx="249387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0    5    10    15  </a:t>
              </a:r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  </a:t>
              </a:r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20   25 </a:t>
              </a:r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   </a:t>
              </a:r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30   </a:t>
              </a:r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35  </a:t>
              </a:r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37</a:t>
              </a:r>
            </a:p>
            <a:p>
              <a:r>
                <a:rPr lang="en-US" sz="1000" b="1" dirty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                       weeks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1021415" y="2843446"/>
            <a:ext cx="2949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C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30871092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</TotalTime>
  <Words>171</Words>
  <Application>Microsoft Office PowerPoint</Application>
  <PresentationFormat>Custom</PresentationFormat>
  <Paragraphs>1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Tennesse State Univerist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, Hongwei</dc:creator>
  <cp:lastModifiedBy>Si, Hongwei</cp:lastModifiedBy>
  <cp:revision>12</cp:revision>
  <dcterms:created xsi:type="dcterms:W3CDTF">2018-05-29T15:40:38Z</dcterms:created>
  <dcterms:modified xsi:type="dcterms:W3CDTF">2018-06-23T19:12:53Z</dcterms:modified>
</cp:coreProperties>
</file>